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1887200" cy="11887200"/>
  <p:notesSz cx="6858000" cy="9144000"/>
  <p:defaultTextStyle>
    <a:defPPr>
      <a:defRPr lang="en-US"/>
    </a:defPPr>
    <a:lvl1pPr marL="0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1pPr>
    <a:lvl2pPr marL="679262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2pPr>
    <a:lvl3pPr marL="1358524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3pPr>
    <a:lvl4pPr marL="2037786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4pPr>
    <a:lvl5pPr marL="2717048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5pPr>
    <a:lvl6pPr marL="3396310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6pPr>
    <a:lvl7pPr marL="4075572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7pPr>
    <a:lvl8pPr marL="4754834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8pPr>
    <a:lvl9pPr marL="5434096" algn="l" defTabSz="679262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on Heston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5" d="100"/>
          <a:sy n="25" d="100"/>
        </p:scale>
        <p:origin x="-2648" y="-408"/>
      </p:cViewPr>
      <p:guideLst>
        <p:guide orient="horz" pos="3744"/>
        <p:guide pos="37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618970-340F-E044-BE04-55A31F0893F2}" type="datetimeFigureOut">
              <a:rPr lang="en-US" smtClean="0"/>
              <a:t>9/2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1EAFA4-8E29-3D43-A53C-8A2A17EFB0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319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1EAFA4-8E29-3D43-A53C-8A2A17EFB0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005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3692738"/>
            <a:ext cx="10104120" cy="25480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83080" y="6736080"/>
            <a:ext cx="8321040" cy="30378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92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85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377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170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96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75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548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340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47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02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204100" y="825500"/>
            <a:ext cx="3477418" cy="1758039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1843" y="825500"/>
            <a:ext cx="10234137" cy="1758039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741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863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9007" y="7638628"/>
            <a:ext cx="10104120" cy="2360930"/>
          </a:xfrm>
        </p:spPr>
        <p:txBody>
          <a:bodyPr anchor="t"/>
          <a:lstStyle>
            <a:lvl1pPr algn="l">
              <a:defRPr sz="5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9007" y="5038303"/>
            <a:ext cx="10104120" cy="2600324"/>
          </a:xfrm>
        </p:spPr>
        <p:txBody>
          <a:bodyPr anchor="b"/>
          <a:lstStyle>
            <a:lvl1pPr marL="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1pPr>
            <a:lvl2pPr marL="679262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358524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3778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1704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39631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07557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7548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43409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236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1843" y="4807163"/>
            <a:ext cx="6855778" cy="13598737"/>
          </a:xfrm>
        </p:spPr>
        <p:txBody>
          <a:bodyPr/>
          <a:lstStyle>
            <a:lvl1pPr>
              <a:defRPr sz="4200"/>
            </a:lvl1pPr>
            <a:lvl2pPr>
              <a:defRPr sz="36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25740" y="4807163"/>
            <a:ext cx="6855778" cy="13598737"/>
          </a:xfrm>
        </p:spPr>
        <p:txBody>
          <a:bodyPr/>
          <a:lstStyle>
            <a:lvl1pPr>
              <a:defRPr sz="4200"/>
            </a:lvl1pPr>
            <a:lvl2pPr>
              <a:defRPr sz="36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32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4360" y="476039"/>
            <a:ext cx="10698480" cy="19812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2660862"/>
            <a:ext cx="5252244" cy="1108921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79262" indent="0">
              <a:buNone/>
              <a:defRPr sz="3000" b="1"/>
            </a:lvl2pPr>
            <a:lvl3pPr marL="1358524" indent="0">
              <a:buNone/>
              <a:defRPr sz="2700" b="1"/>
            </a:lvl3pPr>
            <a:lvl4pPr marL="2037786" indent="0">
              <a:buNone/>
              <a:defRPr sz="2400" b="1"/>
            </a:lvl4pPr>
            <a:lvl5pPr marL="2717048" indent="0">
              <a:buNone/>
              <a:defRPr sz="2400" b="1"/>
            </a:lvl5pPr>
            <a:lvl6pPr marL="3396310" indent="0">
              <a:buNone/>
              <a:defRPr sz="2400" b="1"/>
            </a:lvl6pPr>
            <a:lvl7pPr marL="4075572" indent="0">
              <a:buNone/>
              <a:defRPr sz="2400" b="1"/>
            </a:lvl7pPr>
            <a:lvl8pPr marL="4754834" indent="0">
              <a:buNone/>
              <a:defRPr sz="2400" b="1"/>
            </a:lvl8pPr>
            <a:lvl9pPr marL="5434096" indent="0">
              <a:buNone/>
              <a:defRPr sz="2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4360" y="3769783"/>
            <a:ext cx="5252244" cy="6848899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38533" y="2660862"/>
            <a:ext cx="5254308" cy="1108921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79262" indent="0">
              <a:buNone/>
              <a:defRPr sz="3000" b="1"/>
            </a:lvl2pPr>
            <a:lvl3pPr marL="1358524" indent="0">
              <a:buNone/>
              <a:defRPr sz="2700" b="1"/>
            </a:lvl3pPr>
            <a:lvl4pPr marL="2037786" indent="0">
              <a:buNone/>
              <a:defRPr sz="2400" b="1"/>
            </a:lvl4pPr>
            <a:lvl5pPr marL="2717048" indent="0">
              <a:buNone/>
              <a:defRPr sz="2400" b="1"/>
            </a:lvl5pPr>
            <a:lvl6pPr marL="3396310" indent="0">
              <a:buNone/>
              <a:defRPr sz="2400" b="1"/>
            </a:lvl6pPr>
            <a:lvl7pPr marL="4075572" indent="0">
              <a:buNone/>
              <a:defRPr sz="2400" b="1"/>
            </a:lvl7pPr>
            <a:lvl8pPr marL="4754834" indent="0">
              <a:buNone/>
              <a:defRPr sz="2400" b="1"/>
            </a:lvl8pPr>
            <a:lvl9pPr marL="5434096" indent="0">
              <a:buNone/>
              <a:defRPr sz="2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38533" y="3769783"/>
            <a:ext cx="5254308" cy="6848899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698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659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75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4361" y="473287"/>
            <a:ext cx="3910807" cy="2014220"/>
          </a:xfrm>
        </p:spPr>
        <p:txBody>
          <a:bodyPr anchor="b"/>
          <a:lstStyle>
            <a:lvl1pPr algn="l">
              <a:defRPr sz="3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47565" y="473287"/>
            <a:ext cx="6645275" cy="10145396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4361" y="2487507"/>
            <a:ext cx="3910807" cy="8131176"/>
          </a:xfrm>
        </p:spPr>
        <p:txBody>
          <a:bodyPr/>
          <a:lstStyle>
            <a:lvl1pPr marL="0" indent="0">
              <a:buNone/>
              <a:defRPr sz="2100"/>
            </a:lvl1pPr>
            <a:lvl2pPr marL="679262" indent="0">
              <a:buNone/>
              <a:defRPr sz="1800"/>
            </a:lvl2pPr>
            <a:lvl3pPr marL="1358524" indent="0">
              <a:buNone/>
              <a:defRPr sz="1500"/>
            </a:lvl3pPr>
            <a:lvl4pPr marL="2037786" indent="0">
              <a:buNone/>
              <a:defRPr sz="1300"/>
            </a:lvl4pPr>
            <a:lvl5pPr marL="2717048" indent="0">
              <a:buNone/>
              <a:defRPr sz="1300"/>
            </a:lvl5pPr>
            <a:lvl6pPr marL="3396310" indent="0">
              <a:buNone/>
              <a:defRPr sz="1300"/>
            </a:lvl6pPr>
            <a:lvl7pPr marL="4075572" indent="0">
              <a:buNone/>
              <a:defRPr sz="1300"/>
            </a:lvl7pPr>
            <a:lvl8pPr marL="4754834" indent="0">
              <a:buNone/>
              <a:defRPr sz="1300"/>
            </a:lvl8pPr>
            <a:lvl9pPr marL="5434096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434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9974" y="8321040"/>
            <a:ext cx="7132320" cy="982346"/>
          </a:xfrm>
        </p:spPr>
        <p:txBody>
          <a:bodyPr anchor="b"/>
          <a:lstStyle>
            <a:lvl1pPr algn="l">
              <a:defRPr sz="3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29974" y="1062143"/>
            <a:ext cx="7132320" cy="7132320"/>
          </a:xfrm>
        </p:spPr>
        <p:txBody>
          <a:bodyPr/>
          <a:lstStyle>
            <a:lvl1pPr marL="0" indent="0">
              <a:buNone/>
              <a:defRPr sz="4800"/>
            </a:lvl1pPr>
            <a:lvl2pPr marL="679262" indent="0">
              <a:buNone/>
              <a:defRPr sz="4200"/>
            </a:lvl2pPr>
            <a:lvl3pPr marL="1358524" indent="0">
              <a:buNone/>
              <a:defRPr sz="3600"/>
            </a:lvl3pPr>
            <a:lvl4pPr marL="2037786" indent="0">
              <a:buNone/>
              <a:defRPr sz="3000"/>
            </a:lvl4pPr>
            <a:lvl5pPr marL="2717048" indent="0">
              <a:buNone/>
              <a:defRPr sz="3000"/>
            </a:lvl5pPr>
            <a:lvl6pPr marL="3396310" indent="0">
              <a:buNone/>
              <a:defRPr sz="3000"/>
            </a:lvl6pPr>
            <a:lvl7pPr marL="4075572" indent="0">
              <a:buNone/>
              <a:defRPr sz="3000"/>
            </a:lvl7pPr>
            <a:lvl8pPr marL="4754834" indent="0">
              <a:buNone/>
              <a:defRPr sz="3000"/>
            </a:lvl8pPr>
            <a:lvl9pPr marL="5434096" indent="0">
              <a:buNone/>
              <a:defRPr sz="3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29974" y="9303386"/>
            <a:ext cx="7132320" cy="1395094"/>
          </a:xfrm>
        </p:spPr>
        <p:txBody>
          <a:bodyPr/>
          <a:lstStyle>
            <a:lvl1pPr marL="0" indent="0">
              <a:buNone/>
              <a:defRPr sz="2100"/>
            </a:lvl1pPr>
            <a:lvl2pPr marL="679262" indent="0">
              <a:buNone/>
              <a:defRPr sz="1800"/>
            </a:lvl2pPr>
            <a:lvl3pPr marL="1358524" indent="0">
              <a:buNone/>
              <a:defRPr sz="1500"/>
            </a:lvl3pPr>
            <a:lvl4pPr marL="2037786" indent="0">
              <a:buNone/>
              <a:defRPr sz="1300"/>
            </a:lvl4pPr>
            <a:lvl5pPr marL="2717048" indent="0">
              <a:buNone/>
              <a:defRPr sz="1300"/>
            </a:lvl5pPr>
            <a:lvl6pPr marL="3396310" indent="0">
              <a:buNone/>
              <a:defRPr sz="1300"/>
            </a:lvl6pPr>
            <a:lvl7pPr marL="4075572" indent="0">
              <a:buNone/>
              <a:defRPr sz="1300"/>
            </a:lvl7pPr>
            <a:lvl8pPr marL="4754834" indent="0">
              <a:buNone/>
              <a:defRPr sz="1300"/>
            </a:lvl8pPr>
            <a:lvl9pPr marL="5434096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595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360" y="476039"/>
            <a:ext cx="10698480" cy="1981200"/>
          </a:xfrm>
          <a:prstGeom prst="rect">
            <a:avLst/>
          </a:prstGeom>
        </p:spPr>
        <p:txBody>
          <a:bodyPr vert="horz" lIns="135852" tIns="67926" rIns="135852" bIns="6792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2773681"/>
            <a:ext cx="10698480" cy="7845003"/>
          </a:xfrm>
          <a:prstGeom prst="rect">
            <a:avLst/>
          </a:prstGeom>
        </p:spPr>
        <p:txBody>
          <a:bodyPr vert="horz" lIns="135852" tIns="67926" rIns="135852" bIns="6792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360" y="11017674"/>
            <a:ext cx="2773680" cy="632883"/>
          </a:xfrm>
          <a:prstGeom prst="rect">
            <a:avLst/>
          </a:prstGeom>
        </p:spPr>
        <p:txBody>
          <a:bodyPr vert="horz" lIns="135852" tIns="67926" rIns="135852" bIns="67926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82197-96F9-B846-9EF3-53FD07C70B5C}" type="datetimeFigureOut">
              <a:rPr lang="en-US" smtClean="0"/>
              <a:t>9/2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61460" y="11017674"/>
            <a:ext cx="3764280" cy="632883"/>
          </a:xfrm>
          <a:prstGeom prst="rect">
            <a:avLst/>
          </a:prstGeom>
        </p:spPr>
        <p:txBody>
          <a:bodyPr vert="horz" lIns="135852" tIns="67926" rIns="135852" bIns="67926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19160" y="11017674"/>
            <a:ext cx="2773680" cy="632883"/>
          </a:xfrm>
          <a:prstGeom prst="rect">
            <a:avLst/>
          </a:prstGeom>
        </p:spPr>
        <p:txBody>
          <a:bodyPr vert="horz" lIns="135852" tIns="67926" rIns="135852" bIns="67926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F60A9-2EDD-5D44-91CB-62A7EB6B4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860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79262" rtl="0" eaLnBrk="1" latinLnBrk="0" hangingPunct="1">
        <a:spcBef>
          <a:spcPct val="0"/>
        </a:spcBef>
        <a:buNone/>
        <a:defRPr sz="6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9447" indent="-509447" algn="l" defTabSz="679262" rtl="0" eaLnBrk="1" latinLnBrk="0" hangingPunct="1">
        <a:spcBef>
          <a:spcPct val="20000"/>
        </a:spcBef>
        <a:buFont typeface="Arial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1pPr>
      <a:lvl2pPr marL="1103801" indent="-424539" algn="l" defTabSz="679262" rtl="0" eaLnBrk="1" latinLnBrk="0" hangingPunct="1">
        <a:spcBef>
          <a:spcPct val="20000"/>
        </a:spcBef>
        <a:buFont typeface="Arial"/>
        <a:buChar char="–"/>
        <a:defRPr sz="4200" kern="1200">
          <a:solidFill>
            <a:schemeClr val="tx1"/>
          </a:solidFill>
          <a:latin typeface="+mn-lt"/>
          <a:ea typeface="+mn-ea"/>
          <a:cs typeface="+mn-cs"/>
        </a:defRPr>
      </a:lvl2pPr>
      <a:lvl3pPr marL="1698155" indent="-339631" algn="l" defTabSz="679262" rtl="0" eaLnBrk="1" latinLnBrk="0" hangingPunct="1">
        <a:spcBef>
          <a:spcPct val="20000"/>
        </a:spcBef>
        <a:buFont typeface="Arial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377417" indent="-339631" algn="l" defTabSz="679262" rtl="0" eaLnBrk="1" latinLnBrk="0" hangingPunct="1">
        <a:spcBef>
          <a:spcPct val="20000"/>
        </a:spcBef>
        <a:buFont typeface="Arial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56679" indent="-339631" algn="l" defTabSz="679262" rtl="0" eaLnBrk="1" latinLnBrk="0" hangingPunct="1">
        <a:spcBef>
          <a:spcPct val="20000"/>
        </a:spcBef>
        <a:buFont typeface="Arial"/>
        <a:buChar char="»"/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735941" indent="-339631" algn="l" defTabSz="679262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415203" indent="-339631" algn="l" defTabSz="679262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094465" indent="-339631" algn="l" defTabSz="679262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5773727" indent="-339631" algn="l" defTabSz="679262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79262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58524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37786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17048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96310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075572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754834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34096" algn="l" defTabSz="679262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8.jpeg"/><Relationship Id="rId12" Type="http://schemas.microsoft.com/office/2007/relationships/hdphoto" Target="../media/hdphoto2.wdp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microsoft.com/office/2007/relationships/hdphoto" Target="../media/hdphoto1.wdp"/><Relationship Id="rId9" Type="http://schemas.openxmlformats.org/officeDocument/2006/relationships/image" Target="../media/image6.JPG"/><Relationship Id="rId10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AV MSN bigger scale_(c2)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0" t="23926" r="27313" b="9062"/>
          <a:stretch/>
        </p:blipFill>
        <p:spPr>
          <a:xfrm>
            <a:off x="17309170" y="7250075"/>
            <a:ext cx="4586064" cy="4572000"/>
          </a:xfrm>
          <a:prstGeom prst="rect">
            <a:avLst/>
          </a:prstGeom>
        </p:spPr>
      </p:pic>
      <p:pic>
        <p:nvPicPr>
          <p:cNvPr id="26" name="Picture 25" descr="MSN HSV scale bar_(c1)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6" t="8736" r="10396" b="7878"/>
          <a:stretch/>
        </p:blipFill>
        <p:spPr>
          <a:xfrm>
            <a:off x="11703677" y="7250075"/>
            <a:ext cx="4571039" cy="4572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-117258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71218" y="3344336"/>
            <a:ext cx="2247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463543" y="3955867"/>
            <a:ext cx="4914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V1-CaMKII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903653" y="7268640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V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Arc 11"/>
          <p:cNvSpPr/>
          <p:nvPr/>
        </p:nvSpPr>
        <p:spPr>
          <a:xfrm>
            <a:off x="21650260" y="486577"/>
            <a:ext cx="45719" cy="45718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7463451" y="7268640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KII-</a:t>
            </a:r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V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63343" y="1019774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KII-AAV1 (Area X)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88785" y="971550"/>
            <a:ext cx="5006394" cy="4573069"/>
            <a:chOff x="688785" y="971550"/>
            <a:chExt cx="5006394" cy="457306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678"/>
            <a:stretch/>
          </p:blipFill>
          <p:spPr>
            <a:xfrm rot="16200000">
              <a:off x="664597" y="995738"/>
              <a:ext cx="4573069" cy="4524694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780279" y="1057045"/>
              <a:ext cx="49149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KII-AAV</a:t>
              </a:r>
              <a:endParaRPr lang="en-US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Oval 15"/>
            <p:cNvSpPr/>
            <p:nvPr/>
          </p:nvSpPr>
          <p:spPr>
            <a:xfrm>
              <a:off x="1471218" y="2025081"/>
              <a:ext cx="3629025" cy="2543174"/>
            </a:xfrm>
            <a:prstGeom prst="ellipse">
              <a:avLst/>
            </a:prstGeom>
            <a:noFill/>
            <a:ln w="47625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5535854" y="-117258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1071708" y="-117258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6607562" y="-117258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17309170" y="971550"/>
            <a:ext cx="4914900" cy="4573071"/>
            <a:chOff x="17309170" y="971550"/>
            <a:chExt cx="4914900" cy="4573071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52" t="1299" r="7229"/>
            <a:stretch/>
          </p:blipFill>
          <p:spPr>
            <a:xfrm>
              <a:off x="17309170" y="971550"/>
              <a:ext cx="4651663" cy="4573071"/>
            </a:xfrm>
            <a:prstGeom prst="rect">
              <a:avLst/>
            </a:prstGeom>
          </p:spPr>
        </p:pic>
        <p:sp>
          <p:nvSpPr>
            <p:cNvPr id="20" name="Freeform 19"/>
            <p:cNvSpPr/>
            <p:nvPr/>
          </p:nvSpPr>
          <p:spPr>
            <a:xfrm>
              <a:off x="17678325" y="2025081"/>
              <a:ext cx="3314700" cy="3156521"/>
            </a:xfrm>
            <a:custGeom>
              <a:avLst/>
              <a:gdLst>
                <a:gd name="connsiteX0" fmla="*/ 2768600 w 3390900"/>
                <a:gd name="connsiteY0" fmla="*/ 238891 h 3274191"/>
                <a:gd name="connsiteX1" fmla="*/ 2667000 w 3390900"/>
                <a:gd name="connsiteY1" fmla="*/ 264291 h 3274191"/>
                <a:gd name="connsiteX2" fmla="*/ 2628900 w 3390900"/>
                <a:gd name="connsiteY2" fmla="*/ 289691 h 3274191"/>
                <a:gd name="connsiteX3" fmla="*/ 2590800 w 3390900"/>
                <a:gd name="connsiteY3" fmla="*/ 302391 h 3274191"/>
                <a:gd name="connsiteX4" fmla="*/ 2540000 w 3390900"/>
                <a:gd name="connsiteY4" fmla="*/ 327791 h 3274191"/>
                <a:gd name="connsiteX5" fmla="*/ 2489200 w 3390900"/>
                <a:gd name="connsiteY5" fmla="*/ 340491 h 3274191"/>
                <a:gd name="connsiteX6" fmla="*/ 2400300 w 3390900"/>
                <a:gd name="connsiteY6" fmla="*/ 391291 h 3274191"/>
                <a:gd name="connsiteX7" fmla="*/ 2362200 w 3390900"/>
                <a:gd name="connsiteY7" fmla="*/ 403991 h 3274191"/>
                <a:gd name="connsiteX8" fmla="*/ 2324100 w 3390900"/>
                <a:gd name="connsiteY8" fmla="*/ 429391 h 3274191"/>
                <a:gd name="connsiteX9" fmla="*/ 2247900 w 3390900"/>
                <a:gd name="connsiteY9" fmla="*/ 454791 h 3274191"/>
                <a:gd name="connsiteX10" fmla="*/ 2095500 w 3390900"/>
                <a:gd name="connsiteY10" fmla="*/ 518291 h 3274191"/>
                <a:gd name="connsiteX11" fmla="*/ 1981200 w 3390900"/>
                <a:gd name="connsiteY11" fmla="*/ 569091 h 3274191"/>
                <a:gd name="connsiteX12" fmla="*/ 1930400 w 3390900"/>
                <a:gd name="connsiteY12" fmla="*/ 594491 h 3274191"/>
                <a:gd name="connsiteX13" fmla="*/ 1892300 w 3390900"/>
                <a:gd name="connsiteY13" fmla="*/ 619891 h 3274191"/>
                <a:gd name="connsiteX14" fmla="*/ 1841500 w 3390900"/>
                <a:gd name="connsiteY14" fmla="*/ 632591 h 3274191"/>
                <a:gd name="connsiteX15" fmla="*/ 1790700 w 3390900"/>
                <a:gd name="connsiteY15" fmla="*/ 657991 h 3274191"/>
                <a:gd name="connsiteX16" fmla="*/ 1752600 w 3390900"/>
                <a:gd name="connsiteY16" fmla="*/ 683391 h 3274191"/>
                <a:gd name="connsiteX17" fmla="*/ 1701800 w 3390900"/>
                <a:gd name="connsiteY17" fmla="*/ 696091 h 3274191"/>
                <a:gd name="connsiteX18" fmla="*/ 1612900 w 3390900"/>
                <a:gd name="connsiteY18" fmla="*/ 746891 h 3274191"/>
                <a:gd name="connsiteX19" fmla="*/ 1536700 w 3390900"/>
                <a:gd name="connsiteY19" fmla="*/ 797691 h 3274191"/>
                <a:gd name="connsiteX20" fmla="*/ 1498600 w 3390900"/>
                <a:gd name="connsiteY20" fmla="*/ 823091 h 3274191"/>
                <a:gd name="connsiteX21" fmla="*/ 1422400 w 3390900"/>
                <a:gd name="connsiteY21" fmla="*/ 861191 h 3274191"/>
                <a:gd name="connsiteX22" fmla="*/ 1384300 w 3390900"/>
                <a:gd name="connsiteY22" fmla="*/ 873891 h 3274191"/>
                <a:gd name="connsiteX23" fmla="*/ 1346200 w 3390900"/>
                <a:gd name="connsiteY23" fmla="*/ 899291 h 3274191"/>
                <a:gd name="connsiteX24" fmla="*/ 1257300 w 3390900"/>
                <a:gd name="connsiteY24" fmla="*/ 937391 h 3274191"/>
                <a:gd name="connsiteX25" fmla="*/ 1206500 w 3390900"/>
                <a:gd name="connsiteY25" fmla="*/ 962791 h 3274191"/>
                <a:gd name="connsiteX26" fmla="*/ 1117600 w 3390900"/>
                <a:gd name="connsiteY26" fmla="*/ 988191 h 3274191"/>
                <a:gd name="connsiteX27" fmla="*/ 990600 w 3390900"/>
                <a:gd name="connsiteY27" fmla="*/ 1051691 h 3274191"/>
                <a:gd name="connsiteX28" fmla="*/ 914400 w 3390900"/>
                <a:gd name="connsiteY28" fmla="*/ 1089791 h 3274191"/>
                <a:gd name="connsiteX29" fmla="*/ 876300 w 3390900"/>
                <a:gd name="connsiteY29" fmla="*/ 1115191 h 3274191"/>
                <a:gd name="connsiteX30" fmla="*/ 838200 w 3390900"/>
                <a:gd name="connsiteY30" fmla="*/ 1127891 h 3274191"/>
                <a:gd name="connsiteX31" fmla="*/ 762000 w 3390900"/>
                <a:gd name="connsiteY31" fmla="*/ 1178691 h 3274191"/>
                <a:gd name="connsiteX32" fmla="*/ 685800 w 3390900"/>
                <a:gd name="connsiteY32" fmla="*/ 1229491 h 3274191"/>
                <a:gd name="connsiteX33" fmla="*/ 647700 w 3390900"/>
                <a:gd name="connsiteY33" fmla="*/ 1254891 h 3274191"/>
                <a:gd name="connsiteX34" fmla="*/ 609600 w 3390900"/>
                <a:gd name="connsiteY34" fmla="*/ 1280291 h 3274191"/>
                <a:gd name="connsiteX35" fmla="*/ 533400 w 3390900"/>
                <a:gd name="connsiteY35" fmla="*/ 1343791 h 3274191"/>
                <a:gd name="connsiteX36" fmla="*/ 495300 w 3390900"/>
                <a:gd name="connsiteY36" fmla="*/ 1381891 h 3274191"/>
                <a:gd name="connsiteX37" fmla="*/ 469900 w 3390900"/>
                <a:gd name="connsiteY37" fmla="*/ 1419991 h 3274191"/>
                <a:gd name="connsiteX38" fmla="*/ 419100 w 3390900"/>
                <a:gd name="connsiteY38" fmla="*/ 1445391 h 3274191"/>
                <a:gd name="connsiteX39" fmla="*/ 355600 w 3390900"/>
                <a:gd name="connsiteY39" fmla="*/ 1521591 h 3274191"/>
                <a:gd name="connsiteX40" fmla="*/ 330200 w 3390900"/>
                <a:gd name="connsiteY40" fmla="*/ 1559691 h 3274191"/>
                <a:gd name="connsiteX41" fmla="*/ 254000 w 3390900"/>
                <a:gd name="connsiteY41" fmla="*/ 1635891 h 3274191"/>
                <a:gd name="connsiteX42" fmla="*/ 203200 w 3390900"/>
                <a:gd name="connsiteY42" fmla="*/ 1712091 h 3274191"/>
                <a:gd name="connsiteX43" fmla="*/ 177800 w 3390900"/>
                <a:gd name="connsiteY43" fmla="*/ 1750191 h 3274191"/>
                <a:gd name="connsiteX44" fmla="*/ 127000 w 3390900"/>
                <a:gd name="connsiteY44" fmla="*/ 1851791 h 3274191"/>
                <a:gd name="connsiteX45" fmla="*/ 101600 w 3390900"/>
                <a:gd name="connsiteY45" fmla="*/ 1889891 h 3274191"/>
                <a:gd name="connsiteX46" fmla="*/ 88900 w 3390900"/>
                <a:gd name="connsiteY46" fmla="*/ 1927991 h 3274191"/>
                <a:gd name="connsiteX47" fmla="*/ 63500 w 3390900"/>
                <a:gd name="connsiteY47" fmla="*/ 1966091 h 3274191"/>
                <a:gd name="connsiteX48" fmla="*/ 25400 w 3390900"/>
                <a:gd name="connsiteY48" fmla="*/ 2067691 h 3274191"/>
                <a:gd name="connsiteX49" fmla="*/ 0 w 3390900"/>
                <a:gd name="connsiteY49" fmla="*/ 2194691 h 3274191"/>
                <a:gd name="connsiteX50" fmla="*/ 25400 w 3390900"/>
                <a:gd name="connsiteY50" fmla="*/ 2524891 h 3274191"/>
                <a:gd name="connsiteX51" fmla="*/ 50800 w 3390900"/>
                <a:gd name="connsiteY51" fmla="*/ 2601091 h 3274191"/>
                <a:gd name="connsiteX52" fmla="*/ 63500 w 3390900"/>
                <a:gd name="connsiteY52" fmla="*/ 2639191 h 3274191"/>
                <a:gd name="connsiteX53" fmla="*/ 114300 w 3390900"/>
                <a:gd name="connsiteY53" fmla="*/ 2715391 h 3274191"/>
                <a:gd name="connsiteX54" fmla="*/ 139700 w 3390900"/>
                <a:gd name="connsiteY54" fmla="*/ 2753491 h 3274191"/>
                <a:gd name="connsiteX55" fmla="*/ 177800 w 3390900"/>
                <a:gd name="connsiteY55" fmla="*/ 2791591 h 3274191"/>
                <a:gd name="connsiteX56" fmla="*/ 203200 w 3390900"/>
                <a:gd name="connsiteY56" fmla="*/ 2829691 h 3274191"/>
                <a:gd name="connsiteX57" fmla="*/ 241300 w 3390900"/>
                <a:gd name="connsiteY57" fmla="*/ 2855091 h 3274191"/>
                <a:gd name="connsiteX58" fmla="*/ 279400 w 3390900"/>
                <a:gd name="connsiteY58" fmla="*/ 2893191 h 3274191"/>
                <a:gd name="connsiteX59" fmla="*/ 355600 w 3390900"/>
                <a:gd name="connsiteY59" fmla="*/ 2943991 h 3274191"/>
                <a:gd name="connsiteX60" fmla="*/ 393700 w 3390900"/>
                <a:gd name="connsiteY60" fmla="*/ 2982091 h 3274191"/>
                <a:gd name="connsiteX61" fmla="*/ 469900 w 3390900"/>
                <a:gd name="connsiteY61" fmla="*/ 3032891 h 3274191"/>
                <a:gd name="connsiteX62" fmla="*/ 558800 w 3390900"/>
                <a:gd name="connsiteY62" fmla="*/ 3096391 h 3274191"/>
                <a:gd name="connsiteX63" fmla="*/ 596900 w 3390900"/>
                <a:gd name="connsiteY63" fmla="*/ 3134491 h 3274191"/>
                <a:gd name="connsiteX64" fmla="*/ 635000 w 3390900"/>
                <a:gd name="connsiteY64" fmla="*/ 3147191 h 3274191"/>
                <a:gd name="connsiteX65" fmla="*/ 673100 w 3390900"/>
                <a:gd name="connsiteY65" fmla="*/ 3172591 h 3274191"/>
                <a:gd name="connsiteX66" fmla="*/ 749300 w 3390900"/>
                <a:gd name="connsiteY66" fmla="*/ 3197991 h 3274191"/>
                <a:gd name="connsiteX67" fmla="*/ 787400 w 3390900"/>
                <a:gd name="connsiteY67" fmla="*/ 3210691 h 3274191"/>
                <a:gd name="connsiteX68" fmla="*/ 838200 w 3390900"/>
                <a:gd name="connsiteY68" fmla="*/ 3223391 h 3274191"/>
                <a:gd name="connsiteX69" fmla="*/ 914400 w 3390900"/>
                <a:gd name="connsiteY69" fmla="*/ 3248791 h 3274191"/>
                <a:gd name="connsiteX70" fmla="*/ 1028700 w 3390900"/>
                <a:gd name="connsiteY70" fmla="*/ 3274191 h 3274191"/>
                <a:gd name="connsiteX71" fmla="*/ 1562100 w 3390900"/>
                <a:gd name="connsiteY71" fmla="*/ 3261491 h 3274191"/>
                <a:gd name="connsiteX72" fmla="*/ 1676400 w 3390900"/>
                <a:gd name="connsiteY72" fmla="*/ 3236091 h 3274191"/>
                <a:gd name="connsiteX73" fmla="*/ 1765300 w 3390900"/>
                <a:gd name="connsiteY73" fmla="*/ 3210691 h 3274191"/>
                <a:gd name="connsiteX74" fmla="*/ 1803400 w 3390900"/>
                <a:gd name="connsiteY74" fmla="*/ 3185291 h 3274191"/>
                <a:gd name="connsiteX75" fmla="*/ 1879600 w 3390900"/>
                <a:gd name="connsiteY75" fmla="*/ 3159891 h 3274191"/>
                <a:gd name="connsiteX76" fmla="*/ 1917700 w 3390900"/>
                <a:gd name="connsiteY76" fmla="*/ 3147191 h 3274191"/>
                <a:gd name="connsiteX77" fmla="*/ 1968500 w 3390900"/>
                <a:gd name="connsiteY77" fmla="*/ 3121791 h 3274191"/>
                <a:gd name="connsiteX78" fmla="*/ 2082800 w 3390900"/>
                <a:gd name="connsiteY78" fmla="*/ 3058291 h 3274191"/>
                <a:gd name="connsiteX79" fmla="*/ 2120900 w 3390900"/>
                <a:gd name="connsiteY79" fmla="*/ 3020191 h 3274191"/>
                <a:gd name="connsiteX80" fmla="*/ 2159000 w 3390900"/>
                <a:gd name="connsiteY80" fmla="*/ 3007491 h 3274191"/>
                <a:gd name="connsiteX81" fmla="*/ 2197100 w 3390900"/>
                <a:gd name="connsiteY81" fmla="*/ 2982091 h 3274191"/>
                <a:gd name="connsiteX82" fmla="*/ 2222500 w 3390900"/>
                <a:gd name="connsiteY82" fmla="*/ 2943991 h 3274191"/>
                <a:gd name="connsiteX83" fmla="*/ 2260600 w 3390900"/>
                <a:gd name="connsiteY83" fmla="*/ 2918591 h 3274191"/>
                <a:gd name="connsiteX84" fmla="*/ 2273300 w 3390900"/>
                <a:gd name="connsiteY84" fmla="*/ 2880491 h 3274191"/>
                <a:gd name="connsiteX85" fmla="*/ 2311400 w 3390900"/>
                <a:gd name="connsiteY85" fmla="*/ 2842391 h 3274191"/>
                <a:gd name="connsiteX86" fmla="*/ 2336800 w 3390900"/>
                <a:gd name="connsiteY86" fmla="*/ 2804291 h 3274191"/>
                <a:gd name="connsiteX87" fmla="*/ 2374900 w 3390900"/>
                <a:gd name="connsiteY87" fmla="*/ 2753491 h 3274191"/>
                <a:gd name="connsiteX88" fmla="*/ 2425700 w 3390900"/>
                <a:gd name="connsiteY88" fmla="*/ 2651891 h 3274191"/>
                <a:gd name="connsiteX89" fmla="*/ 2451100 w 3390900"/>
                <a:gd name="connsiteY89" fmla="*/ 2613791 h 3274191"/>
                <a:gd name="connsiteX90" fmla="*/ 2476500 w 3390900"/>
                <a:gd name="connsiteY90" fmla="*/ 2537591 h 3274191"/>
                <a:gd name="connsiteX91" fmla="*/ 2489200 w 3390900"/>
                <a:gd name="connsiteY91" fmla="*/ 2499491 h 3274191"/>
                <a:gd name="connsiteX92" fmla="*/ 2514600 w 3390900"/>
                <a:gd name="connsiteY92" fmla="*/ 2448691 h 3274191"/>
                <a:gd name="connsiteX93" fmla="*/ 2527300 w 3390900"/>
                <a:gd name="connsiteY93" fmla="*/ 2397891 h 3274191"/>
                <a:gd name="connsiteX94" fmla="*/ 2540000 w 3390900"/>
                <a:gd name="connsiteY94" fmla="*/ 2359791 h 3274191"/>
                <a:gd name="connsiteX95" fmla="*/ 2552700 w 3390900"/>
                <a:gd name="connsiteY95" fmla="*/ 2308991 h 3274191"/>
                <a:gd name="connsiteX96" fmla="*/ 2565400 w 3390900"/>
                <a:gd name="connsiteY96" fmla="*/ 2270891 h 3274191"/>
                <a:gd name="connsiteX97" fmla="*/ 2578100 w 3390900"/>
                <a:gd name="connsiteY97" fmla="*/ 2220091 h 3274191"/>
                <a:gd name="connsiteX98" fmla="*/ 2603500 w 3390900"/>
                <a:gd name="connsiteY98" fmla="*/ 2169291 h 3274191"/>
                <a:gd name="connsiteX99" fmla="*/ 2654300 w 3390900"/>
                <a:gd name="connsiteY99" fmla="*/ 2042291 h 3274191"/>
                <a:gd name="connsiteX100" fmla="*/ 2667000 w 3390900"/>
                <a:gd name="connsiteY100" fmla="*/ 1978791 h 3274191"/>
                <a:gd name="connsiteX101" fmla="*/ 2692400 w 3390900"/>
                <a:gd name="connsiteY101" fmla="*/ 1902591 h 3274191"/>
                <a:gd name="connsiteX102" fmla="*/ 2705100 w 3390900"/>
                <a:gd name="connsiteY102" fmla="*/ 1864491 h 3274191"/>
                <a:gd name="connsiteX103" fmla="*/ 2717800 w 3390900"/>
                <a:gd name="connsiteY103" fmla="*/ 1813691 h 3274191"/>
                <a:gd name="connsiteX104" fmla="*/ 2743200 w 3390900"/>
                <a:gd name="connsiteY104" fmla="*/ 1775591 h 3274191"/>
                <a:gd name="connsiteX105" fmla="*/ 2755900 w 3390900"/>
                <a:gd name="connsiteY105" fmla="*/ 1737491 h 3274191"/>
                <a:gd name="connsiteX106" fmla="*/ 2781300 w 3390900"/>
                <a:gd name="connsiteY106" fmla="*/ 1686691 h 3274191"/>
                <a:gd name="connsiteX107" fmla="*/ 2794000 w 3390900"/>
                <a:gd name="connsiteY107" fmla="*/ 1648591 h 3274191"/>
                <a:gd name="connsiteX108" fmla="*/ 2819400 w 3390900"/>
                <a:gd name="connsiteY108" fmla="*/ 1597791 h 3274191"/>
                <a:gd name="connsiteX109" fmla="*/ 2844800 w 3390900"/>
                <a:gd name="connsiteY109" fmla="*/ 1521591 h 3274191"/>
                <a:gd name="connsiteX110" fmla="*/ 2895600 w 3390900"/>
                <a:gd name="connsiteY110" fmla="*/ 1432691 h 3274191"/>
                <a:gd name="connsiteX111" fmla="*/ 2921000 w 3390900"/>
                <a:gd name="connsiteY111" fmla="*/ 1394591 h 3274191"/>
                <a:gd name="connsiteX112" fmla="*/ 2933700 w 3390900"/>
                <a:gd name="connsiteY112" fmla="*/ 1356491 h 3274191"/>
                <a:gd name="connsiteX113" fmla="*/ 2959100 w 3390900"/>
                <a:gd name="connsiteY113" fmla="*/ 1318391 h 3274191"/>
                <a:gd name="connsiteX114" fmla="*/ 2984500 w 3390900"/>
                <a:gd name="connsiteY114" fmla="*/ 1242191 h 3274191"/>
                <a:gd name="connsiteX115" fmla="*/ 3022600 w 3390900"/>
                <a:gd name="connsiteY115" fmla="*/ 1165991 h 3274191"/>
                <a:gd name="connsiteX116" fmla="*/ 3048000 w 3390900"/>
                <a:gd name="connsiteY116" fmla="*/ 1127891 h 3274191"/>
                <a:gd name="connsiteX117" fmla="*/ 3060700 w 3390900"/>
                <a:gd name="connsiteY117" fmla="*/ 1089791 h 3274191"/>
                <a:gd name="connsiteX118" fmla="*/ 3086100 w 3390900"/>
                <a:gd name="connsiteY118" fmla="*/ 1038991 h 3274191"/>
                <a:gd name="connsiteX119" fmla="*/ 3111500 w 3390900"/>
                <a:gd name="connsiteY119" fmla="*/ 962791 h 3274191"/>
                <a:gd name="connsiteX120" fmla="*/ 3124200 w 3390900"/>
                <a:gd name="connsiteY120" fmla="*/ 924691 h 3274191"/>
                <a:gd name="connsiteX121" fmla="*/ 3175000 w 3390900"/>
                <a:gd name="connsiteY121" fmla="*/ 772291 h 3274191"/>
                <a:gd name="connsiteX122" fmla="*/ 3187700 w 3390900"/>
                <a:gd name="connsiteY122" fmla="*/ 734191 h 3274191"/>
                <a:gd name="connsiteX123" fmla="*/ 3200400 w 3390900"/>
                <a:gd name="connsiteY123" fmla="*/ 696091 h 3274191"/>
                <a:gd name="connsiteX124" fmla="*/ 3213100 w 3390900"/>
                <a:gd name="connsiteY124" fmla="*/ 645291 h 3274191"/>
                <a:gd name="connsiteX125" fmla="*/ 3238500 w 3390900"/>
                <a:gd name="connsiteY125" fmla="*/ 569091 h 3274191"/>
                <a:gd name="connsiteX126" fmla="*/ 3251200 w 3390900"/>
                <a:gd name="connsiteY126" fmla="*/ 518291 h 3274191"/>
                <a:gd name="connsiteX127" fmla="*/ 3276600 w 3390900"/>
                <a:gd name="connsiteY127" fmla="*/ 442091 h 3274191"/>
                <a:gd name="connsiteX128" fmla="*/ 3314700 w 3390900"/>
                <a:gd name="connsiteY128" fmla="*/ 327791 h 3274191"/>
                <a:gd name="connsiteX129" fmla="*/ 3352800 w 3390900"/>
                <a:gd name="connsiteY129" fmla="*/ 213491 h 3274191"/>
                <a:gd name="connsiteX130" fmla="*/ 3365500 w 3390900"/>
                <a:gd name="connsiteY130" fmla="*/ 175391 h 3274191"/>
                <a:gd name="connsiteX131" fmla="*/ 3390900 w 3390900"/>
                <a:gd name="connsiteY131" fmla="*/ 61091 h 3274191"/>
                <a:gd name="connsiteX132" fmla="*/ 3175000 w 3390900"/>
                <a:gd name="connsiteY132" fmla="*/ 35691 h 3274191"/>
                <a:gd name="connsiteX133" fmla="*/ 3098800 w 3390900"/>
                <a:gd name="connsiteY133" fmla="*/ 61091 h 3274191"/>
                <a:gd name="connsiteX134" fmla="*/ 3009900 w 3390900"/>
                <a:gd name="connsiteY134" fmla="*/ 99191 h 3274191"/>
                <a:gd name="connsiteX135" fmla="*/ 2971800 w 3390900"/>
                <a:gd name="connsiteY135" fmla="*/ 111891 h 3274191"/>
                <a:gd name="connsiteX136" fmla="*/ 2933700 w 3390900"/>
                <a:gd name="connsiteY136" fmla="*/ 137291 h 3274191"/>
                <a:gd name="connsiteX137" fmla="*/ 2895600 w 3390900"/>
                <a:gd name="connsiteY137" fmla="*/ 149991 h 3274191"/>
                <a:gd name="connsiteX138" fmla="*/ 2857500 w 3390900"/>
                <a:gd name="connsiteY138" fmla="*/ 175391 h 3274191"/>
                <a:gd name="connsiteX139" fmla="*/ 2819400 w 3390900"/>
                <a:gd name="connsiteY139" fmla="*/ 188091 h 3274191"/>
                <a:gd name="connsiteX140" fmla="*/ 2705100 w 3390900"/>
                <a:gd name="connsiteY140" fmla="*/ 251591 h 3274191"/>
                <a:gd name="connsiteX141" fmla="*/ 2679700 w 3390900"/>
                <a:gd name="connsiteY141" fmla="*/ 251591 h 3274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</a:cxnLst>
              <a:rect l="l" t="t" r="r" b="b"/>
              <a:pathLst>
                <a:path w="3390900" h="3274191">
                  <a:moveTo>
                    <a:pt x="2768600" y="238891"/>
                  </a:moveTo>
                  <a:cubicBezTo>
                    <a:pt x="2744448" y="243721"/>
                    <a:pt x="2693035" y="251274"/>
                    <a:pt x="2667000" y="264291"/>
                  </a:cubicBezTo>
                  <a:cubicBezTo>
                    <a:pt x="2653348" y="271117"/>
                    <a:pt x="2642552" y="282865"/>
                    <a:pt x="2628900" y="289691"/>
                  </a:cubicBezTo>
                  <a:cubicBezTo>
                    <a:pt x="2616926" y="295678"/>
                    <a:pt x="2603105" y="297118"/>
                    <a:pt x="2590800" y="302391"/>
                  </a:cubicBezTo>
                  <a:cubicBezTo>
                    <a:pt x="2573399" y="309849"/>
                    <a:pt x="2557727" y="321144"/>
                    <a:pt x="2540000" y="327791"/>
                  </a:cubicBezTo>
                  <a:cubicBezTo>
                    <a:pt x="2523657" y="333920"/>
                    <a:pt x="2505543" y="334362"/>
                    <a:pt x="2489200" y="340491"/>
                  </a:cubicBezTo>
                  <a:cubicBezTo>
                    <a:pt x="2400139" y="373889"/>
                    <a:pt x="2473993" y="354445"/>
                    <a:pt x="2400300" y="391291"/>
                  </a:cubicBezTo>
                  <a:cubicBezTo>
                    <a:pt x="2388326" y="397278"/>
                    <a:pt x="2374174" y="398004"/>
                    <a:pt x="2362200" y="403991"/>
                  </a:cubicBezTo>
                  <a:cubicBezTo>
                    <a:pt x="2348548" y="410817"/>
                    <a:pt x="2338048" y="423192"/>
                    <a:pt x="2324100" y="429391"/>
                  </a:cubicBezTo>
                  <a:cubicBezTo>
                    <a:pt x="2299634" y="440265"/>
                    <a:pt x="2271847" y="442817"/>
                    <a:pt x="2247900" y="454791"/>
                  </a:cubicBezTo>
                  <a:cubicBezTo>
                    <a:pt x="2130688" y="513397"/>
                    <a:pt x="2183034" y="496408"/>
                    <a:pt x="2095500" y="518291"/>
                  </a:cubicBezTo>
                  <a:cubicBezTo>
                    <a:pt x="1983427" y="593006"/>
                    <a:pt x="2162560" y="478411"/>
                    <a:pt x="1981200" y="569091"/>
                  </a:cubicBezTo>
                  <a:cubicBezTo>
                    <a:pt x="1964267" y="577558"/>
                    <a:pt x="1946838" y="585098"/>
                    <a:pt x="1930400" y="594491"/>
                  </a:cubicBezTo>
                  <a:cubicBezTo>
                    <a:pt x="1917148" y="602064"/>
                    <a:pt x="1906329" y="613878"/>
                    <a:pt x="1892300" y="619891"/>
                  </a:cubicBezTo>
                  <a:cubicBezTo>
                    <a:pt x="1876257" y="626767"/>
                    <a:pt x="1857843" y="626462"/>
                    <a:pt x="1841500" y="632591"/>
                  </a:cubicBezTo>
                  <a:cubicBezTo>
                    <a:pt x="1823773" y="639238"/>
                    <a:pt x="1807138" y="648598"/>
                    <a:pt x="1790700" y="657991"/>
                  </a:cubicBezTo>
                  <a:cubicBezTo>
                    <a:pt x="1777448" y="665564"/>
                    <a:pt x="1766629" y="677378"/>
                    <a:pt x="1752600" y="683391"/>
                  </a:cubicBezTo>
                  <a:cubicBezTo>
                    <a:pt x="1736557" y="690267"/>
                    <a:pt x="1718733" y="691858"/>
                    <a:pt x="1701800" y="696091"/>
                  </a:cubicBezTo>
                  <a:cubicBezTo>
                    <a:pt x="1570003" y="783956"/>
                    <a:pt x="1774030" y="650213"/>
                    <a:pt x="1612900" y="746891"/>
                  </a:cubicBezTo>
                  <a:cubicBezTo>
                    <a:pt x="1586723" y="762597"/>
                    <a:pt x="1562100" y="780758"/>
                    <a:pt x="1536700" y="797691"/>
                  </a:cubicBezTo>
                  <a:cubicBezTo>
                    <a:pt x="1524000" y="806158"/>
                    <a:pt x="1513080" y="818264"/>
                    <a:pt x="1498600" y="823091"/>
                  </a:cubicBezTo>
                  <a:cubicBezTo>
                    <a:pt x="1402835" y="855013"/>
                    <a:pt x="1520877" y="811952"/>
                    <a:pt x="1422400" y="861191"/>
                  </a:cubicBezTo>
                  <a:cubicBezTo>
                    <a:pt x="1410426" y="867178"/>
                    <a:pt x="1396274" y="867904"/>
                    <a:pt x="1384300" y="873891"/>
                  </a:cubicBezTo>
                  <a:cubicBezTo>
                    <a:pt x="1370648" y="880717"/>
                    <a:pt x="1359452" y="891718"/>
                    <a:pt x="1346200" y="899291"/>
                  </a:cubicBezTo>
                  <a:cubicBezTo>
                    <a:pt x="1261959" y="947429"/>
                    <a:pt x="1328540" y="906859"/>
                    <a:pt x="1257300" y="937391"/>
                  </a:cubicBezTo>
                  <a:cubicBezTo>
                    <a:pt x="1239899" y="944849"/>
                    <a:pt x="1223901" y="955333"/>
                    <a:pt x="1206500" y="962791"/>
                  </a:cubicBezTo>
                  <a:cubicBezTo>
                    <a:pt x="1180993" y="973723"/>
                    <a:pt x="1143379" y="981746"/>
                    <a:pt x="1117600" y="988191"/>
                  </a:cubicBezTo>
                  <a:cubicBezTo>
                    <a:pt x="1026877" y="1048673"/>
                    <a:pt x="1071016" y="1031587"/>
                    <a:pt x="990600" y="1051691"/>
                  </a:cubicBezTo>
                  <a:cubicBezTo>
                    <a:pt x="881411" y="1124484"/>
                    <a:pt x="1019560" y="1037211"/>
                    <a:pt x="914400" y="1089791"/>
                  </a:cubicBezTo>
                  <a:cubicBezTo>
                    <a:pt x="900748" y="1096617"/>
                    <a:pt x="889952" y="1108365"/>
                    <a:pt x="876300" y="1115191"/>
                  </a:cubicBezTo>
                  <a:cubicBezTo>
                    <a:pt x="864326" y="1121178"/>
                    <a:pt x="849902" y="1121390"/>
                    <a:pt x="838200" y="1127891"/>
                  </a:cubicBezTo>
                  <a:cubicBezTo>
                    <a:pt x="811515" y="1142716"/>
                    <a:pt x="787400" y="1161758"/>
                    <a:pt x="762000" y="1178691"/>
                  </a:cubicBezTo>
                  <a:lnTo>
                    <a:pt x="685800" y="1229491"/>
                  </a:lnTo>
                  <a:lnTo>
                    <a:pt x="647700" y="1254891"/>
                  </a:lnTo>
                  <a:cubicBezTo>
                    <a:pt x="635000" y="1263358"/>
                    <a:pt x="620393" y="1269498"/>
                    <a:pt x="609600" y="1280291"/>
                  </a:cubicBezTo>
                  <a:cubicBezTo>
                    <a:pt x="498290" y="1391601"/>
                    <a:pt x="639488" y="1255384"/>
                    <a:pt x="533400" y="1343791"/>
                  </a:cubicBezTo>
                  <a:cubicBezTo>
                    <a:pt x="519602" y="1355289"/>
                    <a:pt x="506798" y="1368093"/>
                    <a:pt x="495300" y="1381891"/>
                  </a:cubicBezTo>
                  <a:cubicBezTo>
                    <a:pt x="485529" y="1393617"/>
                    <a:pt x="481626" y="1410220"/>
                    <a:pt x="469900" y="1419991"/>
                  </a:cubicBezTo>
                  <a:cubicBezTo>
                    <a:pt x="455356" y="1432111"/>
                    <a:pt x="436033" y="1436924"/>
                    <a:pt x="419100" y="1445391"/>
                  </a:cubicBezTo>
                  <a:cubicBezTo>
                    <a:pt x="356037" y="1539986"/>
                    <a:pt x="437088" y="1423805"/>
                    <a:pt x="355600" y="1521591"/>
                  </a:cubicBezTo>
                  <a:cubicBezTo>
                    <a:pt x="345829" y="1533317"/>
                    <a:pt x="340341" y="1548283"/>
                    <a:pt x="330200" y="1559691"/>
                  </a:cubicBezTo>
                  <a:cubicBezTo>
                    <a:pt x="306335" y="1586539"/>
                    <a:pt x="273925" y="1606003"/>
                    <a:pt x="254000" y="1635891"/>
                  </a:cubicBezTo>
                  <a:lnTo>
                    <a:pt x="203200" y="1712091"/>
                  </a:lnTo>
                  <a:cubicBezTo>
                    <a:pt x="194733" y="1724791"/>
                    <a:pt x="184626" y="1736539"/>
                    <a:pt x="177800" y="1750191"/>
                  </a:cubicBezTo>
                  <a:cubicBezTo>
                    <a:pt x="160867" y="1784058"/>
                    <a:pt x="148003" y="1820286"/>
                    <a:pt x="127000" y="1851791"/>
                  </a:cubicBezTo>
                  <a:cubicBezTo>
                    <a:pt x="118533" y="1864491"/>
                    <a:pt x="108426" y="1876239"/>
                    <a:pt x="101600" y="1889891"/>
                  </a:cubicBezTo>
                  <a:cubicBezTo>
                    <a:pt x="95613" y="1901865"/>
                    <a:pt x="94887" y="1916017"/>
                    <a:pt x="88900" y="1927991"/>
                  </a:cubicBezTo>
                  <a:cubicBezTo>
                    <a:pt x="82074" y="1941643"/>
                    <a:pt x="71073" y="1952839"/>
                    <a:pt x="63500" y="1966091"/>
                  </a:cubicBezTo>
                  <a:cubicBezTo>
                    <a:pt x="37427" y="2011718"/>
                    <a:pt x="36115" y="2017687"/>
                    <a:pt x="25400" y="2067691"/>
                  </a:cubicBezTo>
                  <a:cubicBezTo>
                    <a:pt x="16354" y="2109904"/>
                    <a:pt x="0" y="2194691"/>
                    <a:pt x="0" y="2194691"/>
                  </a:cubicBezTo>
                  <a:cubicBezTo>
                    <a:pt x="3025" y="2255185"/>
                    <a:pt x="2093" y="2431663"/>
                    <a:pt x="25400" y="2524891"/>
                  </a:cubicBezTo>
                  <a:cubicBezTo>
                    <a:pt x="31894" y="2550866"/>
                    <a:pt x="42333" y="2575691"/>
                    <a:pt x="50800" y="2601091"/>
                  </a:cubicBezTo>
                  <a:cubicBezTo>
                    <a:pt x="55033" y="2613791"/>
                    <a:pt x="56074" y="2628052"/>
                    <a:pt x="63500" y="2639191"/>
                  </a:cubicBezTo>
                  <a:lnTo>
                    <a:pt x="114300" y="2715391"/>
                  </a:lnTo>
                  <a:cubicBezTo>
                    <a:pt x="122767" y="2728091"/>
                    <a:pt x="128907" y="2742698"/>
                    <a:pt x="139700" y="2753491"/>
                  </a:cubicBezTo>
                  <a:cubicBezTo>
                    <a:pt x="152400" y="2766191"/>
                    <a:pt x="166302" y="2777793"/>
                    <a:pt x="177800" y="2791591"/>
                  </a:cubicBezTo>
                  <a:cubicBezTo>
                    <a:pt x="187571" y="2803317"/>
                    <a:pt x="192407" y="2818898"/>
                    <a:pt x="203200" y="2829691"/>
                  </a:cubicBezTo>
                  <a:cubicBezTo>
                    <a:pt x="213993" y="2840484"/>
                    <a:pt x="229574" y="2845320"/>
                    <a:pt x="241300" y="2855091"/>
                  </a:cubicBezTo>
                  <a:cubicBezTo>
                    <a:pt x="255098" y="2866589"/>
                    <a:pt x="265223" y="2882164"/>
                    <a:pt x="279400" y="2893191"/>
                  </a:cubicBezTo>
                  <a:cubicBezTo>
                    <a:pt x="303497" y="2911933"/>
                    <a:pt x="334014" y="2922405"/>
                    <a:pt x="355600" y="2943991"/>
                  </a:cubicBezTo>
                  <a:cubicBezTo>
                    <a:pt x="368300" y="2956691"/>
                    <a:pt x="379523" y="2971064"/>
                    <a:pt x="393700" y="2982091"/>
                  </a:cubicBezTo>
                  <a:cubicBezTo>
                    <a:pt x="417797" y="3000833"/>
                    <a:pt x="448314" y="3011305"/>
                    <a:pt x="469900" y="3032891"/>
                  </a:cubicBezTo>
                  <a:cubicBezTo>
                    <a:pt x="568962" y="3131953"/>
                    <a:pt x="441787" y="3012811"/>
                    <a:pt x="558800" y="3096391"/>
                  </a:cubicBezTo>
                  <a:cubicBezTo>
                    <a:pt x="573415" y="3106830"/>
                    <a:pt x="581956" y="3124528"/>
                    <a:pt x="596900" y="3134491"/>
                  </a:cubicBezTo>
                  <a:cubicBezTo>
                    <a:pt x="608039" y="3141917"/>
                    <a:pt x="623026" y="3141204"/>
                    <a:pt x="635000" y="3147191"/>
                  </a:cubicBezTo>
                  <a:cubicBezTo>
                    <a:pt x="648652" y="3154017"/>
                    <a:pt x="659152" y="3166392"/>
                    <a:pt x="673100" y="3172591"/>
                  </a:cubicBezTo>
                  <a:cubicBezTo>
                    <a:pt x="697566" y="3183465"/>
                    <a:pt x="723900" y="3189524"/>
                    <a:pt x="749300" y="3197991"/>
                  </a:cubicBezTo>
                  <a:cubicBezTo>
                    <a:pt x="762000" y="3202224"/>
                    <a:pt x="774413" y="3207444"/>
                    <a:pt x="787400" y="3210691"/>
                  </a:cubicBezTo>
                  <a:cubicBezTo>
                    <a:pt x="804333" y="3214924"/>
                    <a:pt x="821482" y="3218375"/>
                    <a:pt x="838200" y="3223391"/>
                  </a:cubicBezTo>
                  <a:cubicBezTo>
                    <a:pt x="863845" y="3231084"/>
                    <a:pt x="888146" y="3243540"/>
                    <a:pt x="914400" y="3248791"/>
                  </a:cubicBezTo>
                  <a:cubicBezTo>
                    <a:pt x="995016" y="3264914"/>
                    <a:pt x="956959" y="3256256"/>
                    <a:pt x="1028700" y="3274191"/>
                  </a:cubicBezTo>
                  <a:lnTo>
                    <a:pt x="1562100" y="3261491"/>
                  </a:lnTo>
                  <a:cubicBezTo>
                    <a:pt x="1629181" y="3258696"/>
                    <a:pt x="1625477" y="3250640"/>
                    <a:pt x="1676400" y="3236091"/>
                  </a:cubicBezTo>
                  <a:cubicBezTo>
                    <a:pt x="1695389" y="3230666"/>
                    <a:pt x="1745000" y="3220841"/>
                    <a:pt x="1765300" y="3210691"/>
                  </a:cubicBezTo>
                  <a:cubicBezTo>
                    <a:pt x="1778952" y="3203865"/>
                    <a:pt x="1789452" y="3191490"/>
                    <a:pt x="1803400" y="3185291"/>
                  </a:cubicBezTo>
                  <a:cubicBezTo>
                    <a:pt x="1827866" y="3174417"/>
                    <a:pt x="1854200" y="3168358"/>
                    <a:pt x="1879600" y="3159891"/>
                  </a:cubicBezTo>
                  <a:cubicBezTo>
                    <a:pt x="1892300" y="3155658"/>
                    <a:pt x="1905726" y="3153178"/>
                    <a:pt x="1917700" y="3147191"/>
                  </a:cubicBezTo>
                  <a:cubicBezTo>
                    <a:pt x="1934633" y="3138724"/>
                    <a:pt x="1952266" y="3131531"/>
                    <a:pt x="1968500" y="3121791"/>
                  </a:cubicBezTo>
                  <a:cubicBezTo>
                    <a:pt x="2077673" y="3056287"/>
                    <a:pt x="2006164" y="3083836"/>
                    <a:pt x="2082800" y="3058291"/>
                  </a:cubicBezTo>
                  <a:cubicBezTo>
                    <a:pt x="2095500" y="3045591"/>
                    <a:pt x="2105956" y="3030154"/>
                    <a:pt x="2120900" y="3020191"/>
                  </a:cubicBezTo>
                  <a:cubicBezTo>
                    <a:pt x="2132039" y="3012765"/>
                    <a:pt x="2147026" y="3013478"/>
                    <a:pt x="2159000" y="3007491"/>
                  </a:cubicBezTo>
                  <a:cubicBezTo>
                    <a:pt x="2172652" y="3000665"/>
                    <a:pt x="2184400" y="2990558"/>
                    <a:pt x="2197100" y="2982091"/>
                  </a:cubicBezTo>
                  <a:cubicBezTo>
                    <a:pt x="2205567" y="2969391"/>
                    <a:pt x="2211707" y="2954784"/>
                    <a:pt x="2222500" y="2943991"/>
                  </a:cubicBezTo>
                  <a:cubicBezTo>
                    <a:pt x="2233293" y="2933198"/>
                    <a:pt x="2251065" y="2930510"/>
                    <a:pt x="2260600" y="2918591"/>
                  </a:cubicBezTo>
                  <a:cubicBezTo>
                    <a:pt x="2268963" y="2908138"/>
                    <a:pt x="2265874" y="2891630"/>
                    <a:pt x="2273300" y="2880491"/>
                  </a:cubicBezTo>
                  <a:cubicBezTo>
                    <a:pt x="2283263" y="2865547"/>
                    <a:pt x="2299902" y="2856189"/>
                    <a:pt x="2311400" y="2842391"/>
                  </a:cubicBezTo>
                  <a:cubicBezTo>
                    <a:pt x="2321171" y="2830665"/>
                    <a:pt x="2327928" y="2816711"/>
                    <a:pt x="2336800" y="2804291"/>
                  </a:cubicBezTo>
                  <a:cubicBezTo>
                    <a:pt x="2349103" y="2787067"/>
                    <a:pt x="2364235" y="2771774"/>
                    <a:pt x="2374900" y="2753491"/>
                  </a:cubicBezTo>
                  <a:cubicBezTo>
                    <a:pt x="2393979" y="2720785"/>
                    <a:pt x="2404697" y="2683396"/>
                    <a:pt x="2425700" y="2651891"/>
                  </a:cubicBezTo>
                  <a:cubicBezTo>
                    <a:pt x="2434167" y="2639191"/>
                    <a:pt x="2444901" y="2627739"/>
                    <a:pt x="2451100" y="2613791"/>
                  </a:cubicBezTo>
                  <a:cubicBezTo>
                    <a:pt x="2461974" y="2589325"/>
                    <a:pt x="2468033" y="2562991"/>
                    <a:pt x="2476500" y="2537591"/>
                  </a:cubicBezTo>
                  <a:cubicBezTo>
                    <a:pt x="2480733" y="2524891"/>
                    <a:pt x="2483213" y="2511465"/>
                    <a:pt x="2489200" y="2499491"/>
                  </a:cubicBezTo>
                  <a:cubicBezTo>
                    <a:pt x="2497667" y="2482558"/>
                    <a:pt x="2507953" y="2466418"/>
                    <a:pt x="2514600" y="2448691"/>
                  </a:cubicBezTo>
                  <a:cubicBezTo>
                    <a:pt x="2520729" y="2432348"/>
                    <a:pt x="2522505" y="2414674"/>
                    <a:pt x="2527300" y="2397891"/>
                  </a:cubicBezTo>
                  <a:cubicBezTo>
                    <a:pt x="2530978" y="2385019"/>
                    <a:pt x="2536322" y="2372663"/>
                    <a:pt x="2540000" y="2359791"/>
                  </a:cubicBezTo>
                  <a:cubicBezTo>
                    <a:pt x="2544795" y="2343008"/>
                    <a:pt x="2547905" y="2325774"/>
                    <a:pt x="2552700" y="2308991"/>
                  </a:cubicBezTo>
                  <a:cubicBezTo>
                    <a:pt x="2556378" y="2296119"/>
                    <a:pt x="2561722" y="2283763"/>
                    <a:pt x="2565400" y="2270891"/>
                  </a:cubicBezTo>
                  <a:cubicBezTo>
                    <a:pt x="2570195" y="2254108"/>
                    <a:pt x="2571971" y="2236434"/>
                    <a:pt x="2578100" y="2220091"/>
                  </a:cubicBezTo>
                  <a:cubicBezTo>
                    <a:pt x="2584747" y="2202364"/>
                    <a:pt x="2596469" y="2186869"/>
                    <a:pt x="2603500" y="2169291"/>
                  </a:cubicBezTo>
                  <a:cubicBezTo>
                    <a:pt x="2666274" y="2012357"/>
                    <a:pt x="2594732" y="2161426"/>
                    <a:pt x="2654300" y="2042291"/>
                  </a:cubicBezTo>
                  <a:cubicBezTo>
                    <a:pt x="2658533" y="2021124"/>
                    <a:pt x="2661320" y="1999616"/>
                    <a:pt x="2667000" y="1978791"/>
                  </a:cubicBezTo>
                  <a:cubicBezTo>
                    <a:pt x="2674045" y="1952960"/>
                    <a:pt x="2683933" y="1927991"/>
                    <a:pt x="2692400" y="1902591"/>
                  </a:cubicBezTo>
                  <a:cubicBezTo>
                    <a:pt x="2696633" y="1889891"/>
                    <a:pt x="2701853" y="1877478"/>
                    <a:pt x="2705100" y="1864491"/>
                  </a:cubicBezTo>
                  <a:cubicBezTo>
                    <a:pt x="2709333" y="1847558"/>
                    <a:pt x="2710924" y="1829734"/>
                    <a:pt x="2717800" y="1813691"/>
                  </a:cubicBezTo>
                  <a:cubicBezTo>
                    <a:pt x="2723813" y="1799662"/>
                    <a:pt x="2736374" y="1789243"/>
                    <a:pt x="2743200" y="1775591"/>
                  </a:cubicBezTo>
                  <a:cubicBezTo>
                    <a:pt x="2749187" y="1763617"/>
                    <a:pt x="2750627" y="1749796"/>
                    <a:pt x="2755900" y="1737491"/>
                  </a:cubicBezTo>
                  <a:cubicBezTo>
                    <a:pt x="2763358" y="1720090"/>
                    <a:pt x="2773842" y="1704092"/>
                    <a:pt x="2781300" y="1686691"/>
                  </a:cubicBezTo>
                  <a:cubicBezTo>
                    <a:pt x="2786573" y="1674386"/>
                    <a:pt x="2788727" y="1660896"/>
                    <a:pt x="2794000" y="1648591"/>
                  </a:cubicBezTo>
                  <a:cubicBezTo>
                    <a:pt x="2801458" y="1631190"/>
                    <a:pt x="2812369" y="1615369"/>
                    <a:pt x="2819400" y="1597791"/>
                  </a:cubicBezTo>
                  <a:cubicBezTo>
                    <a:pt x="2829344" y="1572932"/>
                    <a:pt x="2829948" y="1543868"/>
                    <a:pt x="2844800" y="1521591"/>
                  </a:cubicBezTo>
                  <a:cubicBezTo>
                    <a:pt x="2906683" y="1428766"/>
                    <a:pt x="2831148" y="1545482"/>
                    <a:pt x="2895600" y="1432691"/>
                  </a:cubicBezTo>
                  <a:cubicBezTo>
                    <a:pt x="2903173" y="1419439"/>
                    <a:pt x="2914174" y="1408243"/>
                    <a:pt x="2921000" y="1394591"/>
                  </a:cubicBezTo>
                  <a:cubicBezTo>
                    <a:pt x="2926987" y="1382617"/>
                    <a:pt x="2927713" y="1368465"/>
                    <a:pt x="2933700" y="1356491"/>
                  </a:cubicBezTo>
                  <a:cubicBezTo>
                    <a:pt x="2940526" y="1342839"/>
                    <a:pt x="2952901" y="1332339"/>
                    <a:pt x="2959100" y="1318391"/>
                  </a:cubicBezTo>
                  <a:cubicBezTo>
                    <a:pt x="2969974" y="1293925"/>
                    <a:pt x="2969648" y="1264468"/>
                    <a:pt x="2984500" y="1242191"/>
                  </a:cubicBezTo>
                  <a:cubicBezTo>
                    <a:pt x="3057293" y="1133002"/>
                    <a:pt x="2970020" y="1271151"/>
                    <a:pt x="3022600" y="1165991"/>
                  </a:cubicBezTo>
                  <a:cubicBezTo>
                    <a:pt x="3029426" y="1152339"/>
                    <a:pt x="3041174" y="1141543"/>
                    <a:pt x="3048000" y="1127891"/>
                  </a:cubicBezTo>
                  <a:cubicBezTo>
                    <a:pt x="3053987" y="1115917"/>
                    <a:pt x="3055427" y="1102096"/>
                    <a:pt x="3060700" y="1089791"/>
                  </a:cubicBezTo>
                  <a:cubicBezTo>
                    <a:pt x="3068158" y="1072390"/>
                    <a:pt x="3079069" y="1056569"/>
                    <a:pt x="3086100" y="1038991"/>
                  </a:cubicBezTo>
                  <a:cubicBezTo>
                    <a:pt x="3096044" y="1014132"/>
                    <a:pt x="3103033" y="988191"/>
                    <a:pt x="3111500" y="962791"/>
                  </a:cubicBezTo>
                  <a:lnTo>
                    <a:pt x="3124200" y="924691"/>
                  </a:lnTo>
                  <a:lnTo>
                    <a:pt x="3175000" y="772291"/>
                  </a:lnTo>
                  <a:lnTo>
                    <a:pt x="3187700" y="734191"/>
                  </a:lnTo>
                  <a:cubicBezTo>
                    <a:pt x="3191933" y="721491"/>
                    <a:pt x="3197153" y="709078"/>
                    <a:pt x="3200400" y="696091"/>
                  </a:cubicBezTo>
                  <a:cubicBezTo>
                    <a:pt x="3204633" y="679158"/>
                    <a:pt x="3208084" y="662009"/>
                    <a:pt x="3213100" y="645291"/>
                  </a:cubicBezTo>
                  <a:cubicBezTo>
                    <a:pt x="3220793" y="619646"/>
                    <a:pt x="3232006" y="595066"/>
                    <a:pt x="3238500" y="569091"/>
                  </a:cubicBezTo>
                  <a:cubicBezTo>
                    <a:pt x="3242733" y="552158"/>
                    <a:pt x="3246184" y="535009"/>
                    <a:pt x="3251200" y="518291"/>
                  </a:cubicBezTo>
                  <a:cubicBezTo>
                    <a:pt x="3258893" y="492646"/>
                    <a:pt x="3268133" y="467491"/>
                    <a:pt x="3276600" y="442091"/>
                  </a:cubicBezTo>
                  <a:lnTo>
                    <a:pt x="3314700" y="327791"/>
                  </a:lnTo>
                  <a:lnTo>
                    <a:pt x="3352800" y="213491"/>
                  </a:lnTo>
                  <a:cubicBezTo>
                    <a:pt x="3357033" y="200791"/>
                    <a:pt x="3362875" y="188518"/>
                    <a:pt x="3365500" y="175391"/>
                  </a:cubicBezTo>
                  <a:cubicBezTo>
                    <a:pt x="3381623" y="94775"/>
                    <a:pt x="3372965" y="132832"/>
                    <a:pt x="3390900" y="61091"/>
                  </a:cubicBezTo>
                  <a:cubicBezTo>
                    <a:pt x="3357745" y="-38374"/>
                    <a:pt x="3386461" y="6855"/>
                    <a:pt x="3175000" y="35691"/>
                  </a:cubicBezTo>
                  <a:cubicBezTo>
                    <a:pt x="3148472" y="39309"/>
                    <a:pt x="3124200" y="52624"/>
                    <a:pt x="3098800" y="61091"/>
                  </a:cubicBezTo>
                  <a:cubicBezTo>
                    <a:pt x="3009449" y="90875"/>
                    <a:pt x="3119754" y="52111"/>
                    <a:pt x="3009900" y="99191"/>
                  </a:cubicBezTo>
                  <a:cubicBezTo>
                    <a:pt x="2997595" y="104464"/>
                    <a:pt x="2983774" y="105904"/>
                    <a:pt x="2971800" y="111891"/>
                  </a:cubicBezTo>
                  <a:cubicBezTo>
                    <a:pt x="2958148" y="118717"/>
                    <a:pt x="2947352" y="130465"/>
                    <a:pt x="2933700" y="137291"/>
                  </a:cubicBezTo>
                  <a:cubicBezTo>
                    <a:pt x="2921726" y="143278"/>
                    <a:pt x="2907574" y="144004"/>
                    <a:pt x="2895600" y="149991"/>
                  </a:cubicBezTo>
                  <a:cubicBezTo>
                    <a:pt x="2881948" y="156817"/>
                    <a:pt x="2871152" y="168565"/>
                    <a:pt x="2857500" y="175391"/>
                  </a:cubicBezTo>
                  <a:cubicBezTo>
                    <a:pt x="2845526" y="181378"/>
                    <a:pt x="2831102" y="181590"/>
                    <a:pt x="2819400" y="188091"/>
                  </a:cubicBezTo>
                  <a:cubicBezTo>
                    <a:pt x="2762114" y="219917"/>
                    <a:pt x="2758982" y="240815"/>
                    <a:pt x="2705100" y="251591"/>
                  </a:cubicBezTo>
                  <a:cubicBezTo>
                    <a:pt x="2696798" y="253251"/>
                    <a:pt x="2688167" y="251591"/>
                    <a:pt x="2679700" y="251591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309170" y="1057045"/>
              <a:ext cx="49149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KII-AAV</a:t>
              </a:r>
              <a:endParaRPr lang="en-US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0" y="6141414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535854" y="6141414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1071708" y="6141414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6607562" y="6141414"/>
            <a:ext cx="22479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77560" y="7290953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KII-AAV1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688785" y="7265570"/>
            <a:ext cx="4572000" cy="4572000"/>
            <a:chOff x="534845" y="6380416"/>
            <a:chExt cx="4486210" cy="4375697"/>
          </a:xfrm>
        </p:grpSpPr>
        <p:pic>
          <p:nvPicPr>
            <p:cNvPr id="21" name="Picture 20" descr="Screen Shot 2016-09-10 at 11.10.04 PM.png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82"/>
            <a:stretch/>
          </p:blipFill>
          <p:spPr>
            <a:xfrm>
              <a:off x="534845" y="6380416"/>
              <a:ext cx="4486210" cy="4375697"/>
            </a:xfrm>
            <a:prstGeom prst="rect">
              <a:avLst/>
            </a:prstGeom>
          </p:spPr>
        </p:pic>
        <p:sp>
          <p:nvSpPr>
            <p:cNvPr id="2" name="Isosceles Triangle 1"/>
            <p:cNvSpPr/>
            <p:nvPr/>
          </p:nvSpPr>
          <p:spPr>
            <a:xfrm>
              <a:off x="1669668" y="10050528"/>
              <a:ext cx="313355" cy="586515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Isosceles Triangle 35"/>
            <p:cNvSpPr/>
            <p:nvPr/>
          </p:nvSpPr>
          <p:spPr>
            <a:xfrm>
              <a:off x="3405763" y="7980279"/>
              <a:ext cx="313355" cy="586515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-9609031" y="1712271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V-eDREADDs3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519379" y="1019772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V-</a:t>
            </a:r>
            <a:r>
              <a:rPr lang="en-US" sz="2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 descr="Orange320 Slide 1A FoxP2 40x_(c3+c4).JP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75" t="26172" r="34147" b="26689"/>
          <a:stretch/>
        </p:blipFill>
        <p:spPr>
          <a:xfrm>
            <a:off x="6218730" y="7265571"/>
            <a:ext cx="4572000" cy="457200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6336022" y="7268640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V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218730" y="1014660"/>
            <a:ext cx="4914900" cy="4572000"/>
            <a:chOff x="6218730" y="1014660"/>
            <a:chExt cx="4914900" cy="4572000"/>
          </a:xfrm>
        </p:grpSpPr>
        <p:pic>
          <p:nvPicPr>
            <p:cNvPr id="41" name="Picture 40" descr="LMAN-Area X projections_(c3+c4).JP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5797"/>
            <a:stretch/>
          </p:blipFill>
          <p:spPr>
            <a:xfrm>
              <a:off x="6218730" y="1014660"/>
              <a:ext cx="4616683" cy="4572000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6218730" y="1057045"/>
              <a:ext cx="49149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V</a:t>
              </a:r>
              <a:endParaRPr lang="en-US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824493" y="7268640"/>
            <a:ext cx="4914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KII-AAV</a:t>
            </a:r>
            <a:endParaRPr lang="en-US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1703677" y="1019774"/>
            <a:ext cx="5233816" cy="4581137"/>
            <a:chOff x="11434282" y="1019774"/>
            <a:chExt cx="5233816" cy="4581137"/>
          </a:xfrm>
        </p:grpSpPr>
        <p:pic>
          <p:nvPicPr>
            <p:cNvPr id="46" name="Picture 45" descr="fluorogold_mCherry_scale_z05(c1+c2).JPG"/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87" t="42492" r="26590"/>
            <a:stretch/>
          </p:blipFill>
          <p:spPr>
            <a:xfrm rot="5400000">
              <a:off x="11429713" y="1024343"/>
              <a:ext cx="4581137" cy="4572000"/>
            </a:xfrm>
            <a:prstGeom prst="rect">
              <a:avLst/>
            </a:prstGeom>
          </p:spPr>
        </p:pic>
        <p:sp>
          <p:nvSpPr>
            <p:cNvPr id="37" name="Isosceles Triangle 36"/>
            <p:cNvSpPr/>
            <p:nvPr/>
          </p:nvSpPr>
          <p:spPr>
            <a:xfrm>
              <a:off x="12027407" y="3344336"/>
              <a:ext cx="313355" cy="586515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Isosceles Triangle 37"/>
            <p:cNvSpPr/>
            <p:nvPr/>
          </p:nvSpPr>
          <p:spPr>
            <a:xfrm rot="5400000">
              <a:off x="14303364" y="3511648"/>
              <a:ext cx="371523" cy="586515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1753198" y="1057045"/>
              <a:ext cx="49149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KII-AAV</a:t>
              </a:r>
              <a:endParaRPr lang="en-US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Isosceles Triangle 44"/>
          <p:cNvSpPr/>
          <p:nvPr/>
        </p:nvSpPr>
        <p:spPr>
          <a:xfrm>
            <a:off x="9770664" y="10051731"/>
            <a:ext cx="319347" cy="6128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46"/>
          <p:cNvSpPr/>
          <p:nvPr/>
        </p:nvSpPr>
        <p:spPr>
          <a:xfrm>
            <a:off x="7577019" y="9820821"/>
            <a:ext cx="319347" cy="6128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6884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07</TotalTime>
  <Words>47</Words>
  <Application>Microsoft Macintosh PowerPoint</Application>
  <PresentationFormat>Custom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 Heston</dc:creator>
  <cp:lastModifiedBy>Jon Heston</cp:lastModifiedBy>
  <cp:revision>20</cp:revision>
  <dcterms:created xsi:type="dcterms:W3CDTF">2016-05-02T03:12:59Z</dcterms:created>
  <dcterms:modified xsi:type="dcterms:W3CDTF">2016-10-05T18:01:31Z</dcterms:modified>
</cp:coreProperties>
</file>